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2010" y="2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026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7915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461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9723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0819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1284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6719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9097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5149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9777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844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CA88D-B724-4F6E-A72D-D3376AA354D6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1B909-59D4-4DC7-9C04-DDA5B07258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0327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7F7C6E8-ED58-C269-5E29-D089452D06A2}"/>
              </a:ext>
            </a:extLst>
          </p:cNvPr>
          <p:cNvSpPr txBox="1"/>
          <p:nvPr/>
        </p:nvSpPr>
        <p:spPr>
          <a:xfrm>
            <a:off x="1722508" y="774717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EB2C861-D157-191C-969D-0EA86AB6D1F3}"/>
              </a:ext>
            </a:extLst>
          </p:cNvPr>
          <p:cNvSpPr txBox="1"/>
          <p:nvPr/>
        </p:nvSpPr>
        <p:spPr>
          <a:xfrm>
            <a:off x="3180479" y="775559"/>
            <a:ext cx="1069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AF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DB96E2-A32C-E315-23EC-B0F0CE42919C}"/>
              </a:ext>
            </a:extLst>
          </p:cNvPr>
          <p:cNvSpPr txBox="1"/>
          <p:nvPr/>
        </p:nvSpPr>
        <p:spPr>
          <a:xfrm>
            <a:off x="3862046" y="590051"/>
            <a:ext cx="16864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00 nmol/L BML-111 + PA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611BD5E-9B3C-9CF2-CB88-1781409F6E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1503465" y="1006591"/>
            <a:ext cx="1202046" cy="120204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E1811D6-B589-3CB5-8BC8-DA81B26C1890}"/>
              </a:ext>
            </a:extLst>
          </p:cNvPr>
          <p:cNvSpPr txBox="1"/>
          <p:nvPr/>
        </p:nvSpPr>
        <p:spPr>
          <a:xfrm>
            <a:off x="0" y="217775"/>
            <a:ext cx="2104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 2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64CCC7D8-C456-1DD7-62B8-29159ED154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2791648" y="998296"/>
            <a:ext cx="1207903" cy="120790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99ECFCC-1E7A-756D-7ED3-19B55D1DA59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4091193" y="989238"/>
            <a:ext cx="1207904" cy="120790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11B474F6-2D90-42D2-2B7A-9C5E95ED8D4C}"/>
              </a:ext>
            </a:extLst>
          </p:cNvPr>
          <p:cNvSpPr txBox="1"/>
          <p:nvPr/>
        </p:nvSpPr>
        <p:spPr>
          <a:xfrm rot="16200000">
            <a:off x="1084420" y="1453725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6E6262C-CAF9-2FF4-4C75-FDA288A42A91}"/>
              </a:ext>
            </a:extLst>
          </p:cNvPr>
          <p:cNvSpPr txBox="1"/>
          <p:nvPr/>
        </p:nvSpPr>
        <p:spPr>
          <a:xfrm rot="16200000">
            <a:off x="1094038" y="2784973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400" b="1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47A9F3F-37A1-C170-2E98-78B7B3DBEE6E}"/>
              </a:ext>
            </a:extLst>
          </p:cNvPr>
          <p:cNvCxnSpPr>
            <a:cxnSpLocks/>
          </p:cNvCxnSpPr>
          <p:nvPr/>
        </p:nvCxnSpPr>
        <p:spPr>
          <a:xfrm>
            <a:off x="2526839" y="2143035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Picture 24">
            <a:extLst>
              <a:ext uri="{FF2B5EF4-FFF2-40B4-BE49-F238E27FC236}">
                <a16:creationId xmlns:a16="http://schemas.microsoft.com/office/drawing/2014/main" id="{27C63400-1B3E-31FD-7AC2-2A1B25E2BF3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3951" y="3670420"/>
            <a:ext cx="1188000" cy="118800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B35516C4-AB54-18C1-D4BD-FBC50205B916}"/>
              </a:ext>
            </a:extLst>
          </p:cNvPr>
          <p:cNvSpPr txBox="1"/>
          <p:nvPr/>
        </p:nvSpPr>
        <p:spPr>
          <a:xfrm rot="16200000">
            <a:off x="938000" y="4062015"/>
            <a:ext cx="94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cludin</a:t>
            </a:r>
            <a:endParaRPr lang="en-GB" sz="1400" b="1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4CC64E6-3AF3-2232-797D-DDE1A477E7A0}"/>
              </a:ext>
            </a:extLst>
          </p:cNvPr>
          <p:cNvSpPr txBox="1"/>
          <p:nvPr/>
        </p:nvSpPr>
        <p:spPr>
          <a:xfrm rot="16200000">
            <a:off x="1139053" y="5393263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400" b="1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4363653-9C4D-EF48-5434-CB6444398D29}"/>
              </a:ext>
            </a:extLst>
          </p:cNvPr>
          <p:cNvCxnSpPr>
            <a:cxnSpLocks/>
          </p:cNvCxnSpPr>
          <p:nvPr/>
        </p:nvCxnSpPr>
        <p:spPr>
          <a:xfrm>
            <a:off x="2565504" y="4770375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BB252E6E-88AE-26C8-BA96-EF4E33CD3C5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8203" y="3670420"/>
            <a:ext cx="1188000" cy="118800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B909BB2A-9C04-3DFD-1459-FCA8553C701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235" y="3670420"/>
            <a:ext cx="1188000" cy="11880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92DD1D25-878D-B9B6-8BC0-0A932BD0179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329" y="6311203"/>
            <a:ext cx="1190551" cy="1190551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F478D057-EBD7-1AEA-DCC4-5E98EC5ED8D8}"/>
              </a:ext>
            </a:extLst>
          </p:cNvPr>
          <p:cNvSpPr txBox="1"/>
          <p:nvPr/>
        </p:nvSpPr>
        <p:spPr>
          <a:xfrm rot="16200000">
            <a:off x="862208" y="6750938"/>
            <a:ext cx="11095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95DBA7F-2D12-7501-8E6D-BBF236FC021F}"/>
              </a:ext>
            </a:extLst>
          </p:cNvPr>
          <p:cNvSpPr txBox="1"/>
          <p:nvPr/>
        </p:nvSpPr>
        <p:spPr>
          <a:xfrm rot="16200000">
            <a:off x="1130711" y="8082186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400" b="1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E4F4F247-BEDC-BADC-99C0-9DEAEDE5A4B7}"/>
              </a:ext>
            </a:extLst>
          </p:cNvPr>
          <p:cNvCxnSpPr>
            <a:cxnSpLocks/>
          </p:cNvCxnSpPr>
          <p:nvPr/>
        </p:nvCxnSpPr>
        <p:spPr>
          <a:xfrm>
            <a:off x="2544560" y="7417408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7" name="Picture 56">
            <a:extLst>
              <a:ext uri="{FF2B5EF4-FFF2-40B4-BE49-F238E27FC236}">
                <a16:creationId xmlns:a16="http://schemas.microsoft.com/office/drawing/2014/main" id="{EF91B6DA-21B4-5A49-7A71-8D89AEF56F8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4158" y="6321962"/>
            <a:ext cx="1202045" cy="1202045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71105A66-9BAD-50E3-C41D-B1EECC8296A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235" y="6310827"/>
            <a:ext cx="1188000" cy="1188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DE84EC45-07CF-2EC9-F712-BA6144A6E85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9903" y="2313436"/>
            <a:ext cx="1202046" cy="120204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C78B8CB-EA55-59E9-1FBA-DBB4B048B57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2369" y="2313436"/>
            <a:ext cx="1202046" cy="1202046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F1329F65-35BD-B699-0CB9-BDBD635BB1C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7051" y="2313436"/>
            <a:ext cx="1202046" cy="1202046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123441DA-4A01-42FC-19ED-9BBBF9D6741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3951" y="4968069"/>
            <a:ext cx="1202046" cy="120204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C7B5CB50-3D7D-01BE-AA81-7BF36B7B93E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3378" y="4980418"/>
            <a:ext cx="1202046" cy="120204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C279C5D3-820D-EED5-96B6-CD9577D4151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3674" y="4980418"/>
            <a:ext cx="1202046" cy="1202046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C54F3FFE-890A-9E02-BEF3-63D1177E0A7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2581" y="7623147"/>
            <a:ext cx="1202046" cy="1202046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026A3EEA-3E32-C549-6AD8-170A217717C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4158" y="7631245"/>
            <a:ext cx="1188000" cy="1188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1DCB43E-D495-8346-D18E-C8E81A32158F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235" y="7623147"/>
            <a:ext cx="1202046" cy="120204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CC78414-1B26-6A09-43F3-D65031E4C7C8}"/>
              </a:ext>
            </a:extLst>
          </p:cNvPr>
          <p:cNvSpPr txBox="1"/>
          <p:nvPr/>
        </p:nvSpPr>
        <p:spPr>
          <a:xfrm>
            <a:off x="823608" y="8903190"/>
            <a:ext cx="5496790" cy="10618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Figure S2. BML-111 restores PAF-reduced ZO-1.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  Images of H441 cells treated with </a:t>
            </a:r>
            <a:r>
              <a:rPr lang="en-GB" sz="1050" i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Pseudomonas aeruginosa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filtrate (PAF) or PAF + 200 nmol/L BML-111 and 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immunostained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for ZO-1 (red) or 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Occludin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(green) or E-cadherin (red) with corresponding images of nuclei stained with 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Dapi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(blue). All images were obtained at ×63 magnification. Scale bars (20 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μm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) are shown on control images only but are applicable to all.</a:t>
            </a:r>
          </a:p>
          <a:p>
            <a:pPr algn="just"/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5157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101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eljit Kalsi</dc:creator>
  <cp:lastModifiedBy>Kameljit Kalsi</cp:lastModifiedBy>
  <cp:revision>3</cp:revision>
  <dcterms:created xsi:type="dcterms:W3CDTF">2022-06-02T11:17:06Z</dcterms:created>
  <dcterms:modified xsi:type="dcterms:W3CDTF">2023-03-30T15:44:45Z</dcterms:modified>
</cp:coreProperties>
</file>